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jection</a:t>
            </a:r>
            <a:r>
              <a:rPr lang="en-US" altLang="zh-CN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Pre-operatio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5</c:f>
              <c:strCache>
                <c:ptCount val="4"/>
                <c:pt idx="0">
                  <c:v>Simultaneous vision</c:v>
                </c:pt>
                <c:pt idx="1">
                  <c:v>Fusion</c:v>
                </c:pt>
                <c:pt idx="2">
                  <c:v>Distance stereopsis</c:v>
                </c:pt>
                <c:pt idx="3">
                  <c:v>Near stereopsis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2.8</c:v>
                </c:pt>
                <c:pt idx="1">
                  <c:v>62.5</c:v>
                </c:pt>
                <c:pt idx="2">
                  <c:v>36.1</c:v>
                </c:pt>
                <c:pt idx="3">
                  <c:v>47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6A-49F1-A77E-3DB0AC83DC87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6 months afte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5</c:f>
              <c:strCache>
                <c:ptCount val="4"/>
                <c:pt idx="0">
                  <c:v>Simultaneous vision</c:v>
                </c:pt>
                <c:pt idx="1">
                  <c:v>Fusion</c:v>
                </c:pt>
                <c:pt idx="2">
                  <c:v>Distance stereopsis</c:v>
                </c:pt>
                <c:pt idx="3">
                  <c:v>Near stereopsis</c:v>
                </c:pt>
              </c:strCache>
            </c:strRef>
          </c:cat>
          <c:val>
            <c:numRef>
              <c:f>Sheet1!$C$2:$C$5</c:f>
              <c:numCache>
                <c:formatCode>General</c:formatCode>
                <c:ptCount val="4"/>
                <c:pt idx="0">
                  <c:v>33.299999999999997</c:v>
                </c:pt>
                <c:pt idx="1">
                  <c:v>68.099999999999994</c:v>
                </c:pt>
                <c:pt idx="2">
                  <c:v>44.9</c:v>
                </c:pt>
                <c:pt idx="3">
                  <c:v>39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E6A-49F1-A77E-3DB0AC83DC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44423752"/>
        <c:axId val="744424080"/>
      </c:barChart>
      <c:catAx>
        <c:axId val="7444237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330" b="0" i="0" u="none" strike="noStrike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Binocular visual function</a:t>
                </a:r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744424080"/>
        <c:crosses val="autoZero"/>
        <c:auto val="1"/>
        <c:lblAlgn val="ctr"/>
        <c:lblOffset val="100"/>
        <c:noMultiLvlLbl val="0"/>
      </c:catAx>
      <c:valAx>
        <c:axId val="7444240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ercentage</a:t>
                </a:r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7444237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  <a:r>
              <a:rPr lang="en-US" altLang="zh-CN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lang="zh-CN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Pre-operatio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5</c:f>
              <c:strCache>
                <c:ptCount val="4"/>
                <c:pt idx="0">
                  <c:v>Simultaneous vision</c:v>
                </c:pt>
                <c:pt idx="1">
                  <c:v>Fusion</c:v>
                </c:pt>
                <c:pt idx="2">
                  <c:v>Distance stereopsis</c:v>
                </c:pt>
                <c:pt idx="3">
                  <c:v>near stereopsis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2.8</c:v>
                </c:pt>
                <c:pt idx="1">
                  <c:v>63.9</c:v>
                </c:pt>
                <c:pt idx="2">
                  <c:v>33.299999999999997</c:v>
                </c:pt>
                <c:pt idx="3">
                  <c:v>31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6D7-4631-A0F9-9CBAEFC837B2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6 months afte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5</c:f>
              <c:strCache>
                <c:ptCount val="4"/>
                <c:pt idx="0">
                  <c:v>Simultaneous vision</c:v>
                </c:pt>
                <c:pt idx="1">
                  <c:v>Fusion</c:v>
                </c:pt>
                <c:pt idx="2">
                  <c:v>Distance stereopsis</c:v>
                </c:pt>
                <c:pt idx="3">
                  <c:v>near stereopsis</c:v>
                </c:pt>
              </c:strCache>
            </c:strRef>
          </c:cat>
          <c:val>
            <c:numRef>
              <c:f>Sheet1!$C$2:$C$5</c:f>
              <c:numCache>
                <c:formatCode>General</c:formatCode>
                <c:ptCount val="4"/>
                <c:pt idx="0">
                  <c:v>47.2</c:v>
                </c:pt>
                <c:pt idx="1">
                  <c:v>95.8</c:v>
                </c:pt>
                <c:pt idx="2">
                  <c:v>52.8</c:v>
                </c:pt>
                <c:pt idx="3">
                  <c:v>54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6D7-4631-A0F9-9CBAEFC837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2726936"/>
        <c:axId val="802727920"/>
      </c:barChart>
      <c:catAx>
        <c:axId val="8027269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330" b="0" i="0" u="none" strike="noStrike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Binocular vision function</a:t>
                </a:r>
                <a:endParaRPr lang="zh-CN" altLang="en-US" b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02727920"/>
        <c:crosses val="autoZero"/>
        <c:auto val="1"/>
        <c:lblAlgn val="ctr"/>
        <c:lblOffset val="100"/>
        <c:noMultiLvlLbl val="0"/>
      </c:catAx>
      <c:valAx>
        <c:axId val="8027279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ercentage</a:t>
                </a:r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02726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3C0D64-652E-45D2-B9F6-DA20D32818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4F4419F-2B2F-4D1F-A3E5-6B8FA25429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974488-5A38-4C61-87E6-1301EF24D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BB10B7-5877-44F4-AE8A-2CEC4BE57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527FE1-836A-4401-92F6-6D789CC43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408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93F084-AB32-43FE-8C75-E53AE401D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730A4FE-4440-49FC-816A-6769043E99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94D790-5778-423C-9A84-6BBF9FBF0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7275BB4-35F4-401B-B8D6-FCE3573E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C1DBF8-7313-4D3C-B47C-C08170D7F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753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B20538B-4178-4DA6-8051-80CE662A63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278F4E7-B8D9-424C-ADA6-74CAE9E00D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EEAB3C3-1350-45BB-86CE-805D4454C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47532C-6003-4287-8CC2-303418D22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37FDB7-9EBE-4433-92DC-CAA3BA5BC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1071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C3ED70-C302-423D-9D80-28DBCCDF9A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E518ABF-7A8C-469D-A9E3-13FB2FFF30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938360-6291-4E69-B0E8-D9CDA804C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EEAAC1-AE3B-46D8-827E-FD247CD32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A67354-8827-474A-8402-3F9E0CB36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3823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7C2F08-1F3E-4E57-8A59-BEE49A4675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0DC9EE2-5E10-4196-B2DD-5B9E2A45F5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D010525-9732-478E-86E1-5EA7C4DCC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A78863-782A-4CE7-AED2-2E1D1FB86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7BD701-52CC-4E70-87A5-93CC5B824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346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66F513-A022-47BA-A3D3-91D63D5E3A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F136F34-62E4-4A6F-B8CA-1E70DA90AF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69828A4-5705-48BD-AFDA-1E798FD96F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9B2962A-98B8-48BD-8396-E505B5724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9F66B82-AD04-476F-960B-4097EA787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4BA5EB9-7D2E-4BB3-A112-136CD7259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926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33546E-D8B3-4B46-876E-032CB9DBE5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5EFBAA3-13DF-4084-8F84-272FE22D19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8CDB181-506B-48FB-9BDA-7966413446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2BD0A06-FAAA-43C4-8F3F-1C0EC75680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E6F7C12-70E9-4F44-9402-04BF4C7933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3AE7441-7DBE-4679-8AF9-C0390428A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96CBE1F-3521-4902-9BBD-A5AAE4619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B5E606E-17FD-41FE-BE93-BA4A7A67D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5216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88B40C-B88B-40E0-BAB3-50974CD936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24C1437-68B8-4356-A96C-0BBFCBE04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8515C39-BBC1-4207-9EEA-4EB216061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FDD182F-5C89-48EC-9C66-8AA1156F85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993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4B9F22E-906B-4D35-842F-33B826D10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A228972-A104-4A2D-B89B-3073465BF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9DC4C1E-D04B-4690-B5E1-8F8401E9C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03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19B708-2D6C-4346-86DD-01ABA8E1EA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5AFC902-1E29-416E-ABB8-E73ADACDBC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4BBADF2-561B-4B78-9B41-BDD793F3F6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65CAFB3-5A00-41FE-820C-53374E12A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5AA97F2-A9FA-450C-B1AF-4CD0CAEF3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90AB351-D1EC-45C2-9ED2-248493644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20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258798-F00C-4F3A-9546-88496FED6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5BAB076-2923-4B91-BB31-30F9145EF6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81C4047-E557-4863-8BCF-C1CA42FD50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322FF58-F82A-481C-B619-87BC6E59B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4517C74-1B81-4AFD-882A-89702902E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41781B-EC9B-4614-B0DD-DF4E4FB55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2968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727640F-BA43-47F4-8DDA-8E91FA38A7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56F469E-D6FC-4926-96C4-D08D56612C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2DCB56-FBCF-464E-9AFD-1CB318D8A7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3D33C-6E74-43F4-8359-9AD4BA7D358E}" type="datetimeFigureOut">
              <a:rPr lang="zh-CN" altLang="en-US" smtClean="0"/>
              <a:t>2021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4A595B-6DD3-4F76-9420-D31CE1771A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227088-EA4C-43CB-93D3-7067EB0C98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83B14-60C0-4757-8B96-F986171E6C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928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fu_jing@126.com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A184BBA-47DF-43FD-909A-BFC2A2E2291E}"/>
              </a:ext>
            </a:extLst>
          </p:cNvPr>
          <p:cNvSpPr txBox="1"/>
          <p:nvPr/>
        </p:nvSpPr>
        <p:spPr>
          <a:xfrm>
            <a:off x="571500" y="99000"/>
            <a:ext cx="11049000" cy="6278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zh-CN" sz="2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mparison of Botulinum Toxin Type A with Surgery for the Treatment of Intermittent Exotropia in Children</a:t>
            </a:r>
            <a:endParaRPr lang="zh-CN" altLang="zh-CN" sz="1400" b="1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an Su</a:t>
            </a:r>
            <a:r>
              <a:rPr lang="en-US" altLang="zh-CN" sz="18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Jing Fu</a:t>
            </a:r>
            <a:r>
              <a:rPr lang="en-US" altLang="zh-CN" sz="18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Xiao Wu</a:t>
            </a:r>
            <a:r>
              <a:rPr lang="en-US" altLang="zh-CN" sz="18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Ali Sun</a:t>
            </a:r>
            <a:r>
              <a:rPr lang="en-US" altLang="zh-CN" sz="18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Bowen Zhao</a:t>
            </a:r>
            <a:r>
              <a:rPr lang="en-US" altLang="zh-CN" sz="18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Jie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Hong</a:t>
            </a:r>
            <a:r>
              <a:rPr lang="en-US" altLang="zh-CN" sz="18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lang="zh-CN" altLang="zh-CN" sz="14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. Beijing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ongren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Eye Center, Beijing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ongren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Hospital, Capital Medical University, Beijing Key Laboratory of Ophthalmology</a:t>
            </a:r>
            <a:r>
              <a:rPr lang="zh-CN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＆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isual Science, Beijing, China</a:t>
            </a:r>
            <a:endParaRPr lang="zh-CN" altLang="zh-CN" sz="14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endParaRPr lang="zh-CN" altLang="zh-CN" sz="14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rresponding author: </a:t>
            </a:r>
            <a:endParaRPr lang="zh-CN" altLang="zh-CN" sz="14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r. Jing Fu, M.D., PhD, MPH</a:t>
            </a:r>
            <a:endParaRPr lang="zh-CN" altLang="zh-CN" sz="14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Ophthalmology Department of Beijing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ongren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Hospital, Capital Medical University</a:t>
            </a:r>
            <a:b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</a:b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dd: No.1, Dong Jiao Min Xiang Street,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ongcheng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District, Beijing,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.R.China</a:t>
            </a:r>
            <a:endParaRPr lang="zh-CN" altLang="zh-CN" sz="14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lang="en-US" altLang="zh-CN" sz="1800" u="sng" kern="100" dirty="0">
                <a:solidFill>
                  <a:srgbClr val="0563C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mail: </a:t>
            </a:r>
            <a:r>
              <a:rPr lang="en-US" altLang="zh-CN" sz="1800" u="sng" kern="100" dirty="0">
                <a:solidFill>
                  <a:srgbClr val="0563C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hlinkClick r:id="rId2"/>
              </a:rPr>
              <a:t>fu_jing@126.com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93783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图表 8">
            <a:extLst>
              <a:ext uri="{FF2B5EF4-FFF2-40B4-BE49-F238E27FC236}">
                <a16:creationId xmlns:a16="http://schemas.microsoft.com/office/drawing/2014/main" id="{B6121779-B5F2-4EF7-94EA-6DF19D1706A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75608952"/>
              </p:ext>
            </p:extLst>
          </p:nvPr>
        </p:nvGraphicFramePr>
        <p:xfrm>
          <a:off x="0" y="2420852"/>
          <a:ext cx="5934075" cy="42511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7D3AA2EA-7CDA-4640-8CDC-F2760EE0F3F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7767635"/>
              </p:ext>
            </p:extLst>
          </p:nvPr>
        </p:nvGraphicFramePr>
        <p:xfrm>
          <a:off x="6172199" y="2276189"/>
          <a:ext cx="6105525" cy="43957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2010C9EE-4577-493F-A25D-F4B48351114A}"/>
              </a:ext>
            </a:extLst>
          </p:cNvPr>
          <p:cNvSpPr txBox="1"/>
          <p:nvPr/>
        </p:nvSpPr>
        <p:spPr>
          <a:xfrm>
            <a:off x="154781" y="386060"/>
            <a:ext cx="8351044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fter 6 months of treatment, the percentage of patients with good binocular vision in both groups increased comparing with pre-operation condition. Although the percentage of patients with near stereopsis post-operation in the BTA group was lower than that pre-operation, the difference between the two was not statistically significant (P=0.31).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91033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85</Words>
  <Application>Microsoft Office PowerPoint</Application>
  <PresentationFormat>宽屏</PresentationFormat>
  <Paragraphs>1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苏 寒</dc:creator>
  <cp:lastModifiedBy>苏 寒</cp:lastModifiedBy>
  <cp:revision>9</cp:revision>
  <dcterms:created xsi:type="dcterms:W3CDTF">2020-09-08T14:24:26Z</dcterms:created>
  <dcterms:modified xsi:type="dcterms:W3CDTF">2021-11-08T11:50:24Z</dcterms:modified>
</cp:coreProperties>
</file>